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325" r:id="rId2"/>
  </p:sldIdLst>
  <p:sldSz cx="13320713" cy="108013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2">
          <p15:clr>
            <a:srgbClr val="A4A3A4"/>
          </p15:clr>
        </p15:guide>
        <p15:guide id="2" orient="horz" pos="3379">
          <p15:clr>
            <a:srgbClr val="A4A3A4"/>
          </p15:clr>
        </p15:guide>
        <p15:guide id="3" pos="5595">
          <p15:clr>
            <a:srgbClr val="A4A3A4"/>
          </p15:clr>
        </p15:guide>
        <p15:guide id="4" pos="4336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叶 雪梅" initials="叶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33CC"/>
    <a:srgbClr val="7030A0"/>
    <a:srgbClr val="0000FF"/>
    <a:srgbClr val="005427"/>
    <a:srgbClr val="2E8276"/>
    <a:srgbClr val="00C95E"/>
    <a:srgbClr val="FC726C"/>
    <a:srgbClr val="3333FF"/>
    <a:srgbClr val="E46D0A"/>
    <a:srgbClr val="CC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351" autoAdjust="0"/>
    <p:restoredTop sz="97668" autoAdjust="0"/>
  </p:normalViewPr>
  <p:slideViewPr>
    <p:cSldViewPr>
      <p:cViewPr>
        <p:scale>
          <a:sx n="100" d="100"/>
          <a:sy n="100" d="100"/>
        </p:scale>
        <p:origin x="-216" y="-3000"/>
      </p:cViewPr>
      <p:guideLst>
        <p:guide orient="horz" pos="2552"/>
        <p:guide orient="horz" pos="3379"/>
        <p:guide pos="5595"/>
        <p:guide pos="4336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8B7934-86AC-4FAF-8816-D9EAB701DE84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14450" y="685800"/>
            <a:ext cx="42291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74012-3FCF-423D-89AD-F8EDE1F7B7A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60128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5111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10223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5335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20447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55587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306705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578225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4089400" algn="l" defTabSz="1022350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9054" y="1767722"/>
            <a:ext cx="11322606" cy="3760470"/>
          </a:xfrm>
        </p:spPr>
        <p:txBody>
          <a:bodyPr anchor="b"/>
          <a:lstStyle>
            <a:lvl1pPr algn="ctr">
              <a:defRPr sz="874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65089" y="5673210"/>
            <a:ext cx="9990535" cy="2607825"/>
          </a:xfrm>
        </p:spPr>
        <p:txBody>
          <a:bodyPr/>
          <a:lstStyle>
            <a:lvl1pPr marL="0" indent="0" algn="ctr">
              <a:buNone/>
              <a:defRPr sz="3495"/>
            </a:lvl1pPr>
            <a:lvl2pPr marL="666115" indent="0" algn="ctr">
              <a:buNone/>
              <a:defRPr sz="2915"/>
            </a:lvl2pPr>
            <a:lvl3pPr marL="1332230" indent="0" algn="ctr">
              <a:buNone/>
              <a:defRPr sz="2620"/>
            </a:lvl3pPr>
            <a:lvl4pPr marL="1998345" indent="0" algn="ctr">
              <a:buNone/>
              <a:defRPr sz="2330"/>
            </a:lvl4pPr>
            <a:lvl5pPr marL="2664460" indent="0" algn="ctr">
              <a:buNone/>
              <a:defRPr sz="2330"/>
            </a:lvl5pPr>
            <a:lvl6pPr marL="3329940" indent="0" algn="ctr">
              <a:buNone/>
              <a:defRPr sz="2330"/>
            </a:lvl6pPr>
            <a:lvl7pPr marL="3996055" indent="0" algn="ctr">
              <a:buNone/>
              <a:defRPr sz="2330"/>
            </a:lvl7pPr>
            <a:lvl8pPr marL="4662170" indent="0" algn="ctr">
              <a:buNone/>
              <a:defRPr sz="2330"/>
            </a:lvl8pPr>
            <a:lvl9pPr marL="5328285" indent="0" algn="ctr">
              <a:buNone/>
              <a:defRPr sz="233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532636" y="575072"/>
            <a:ext cx="2872279" cy="915364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15800" y="575072"/>
            <a:ext cx="8450327" cy="915364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8862" y="2692840"/>
            <a:ext cx="11489115" cy="4493061"/>
          </a:xfrm>
        </p:spPr>
        <p:txBody>
          <a:bodyPr anchor="b"/>
          <a:lstStyle>
            <a:lvl1pPr>
              <a:defRPr sz="874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862" y="7228406"/>
            <a:ext cx="11489115" cy="2362795"/>
          </a:xfrm>
        </p:spPr>
        <p:txBody>
          <a:bodyPr/>
          <a:lstStyle>
            <a:lvl1pPr marL="0" indent="0">
              <a:buNone/>
              <a:defRPr sz="3495">
                <a:solidFill>
                  <a:schemeClr val="tx1"/>
                </a:solidFill>
              </a:defRPr>
            </a:lvl1pPr>
            <a:lvl2pPr marL="666115" indent="0">
              <a:buNone/>
              <a:defRPr sz="2915">
                <a:solidFill>
                  <a:schemeClr val="tx1">
                    <a:tint val="75000"/>
                  </a:schemeClr>
                </a:solidFill>
              </a:defRPr>
            </a:lvl2pPr>
            <a:lvl3pPr marL="1332230" indent="0">
              <a:buNone/>
              <a:defRPr sz="2620">
                <a:solidFill>
                  <a:schemeClr val="tx1">
                    <a:tint val="75000"/>
                  </a:schemeClr>
                </a:solidFill>
              </a:defRPr>
            </a:lvl3pPr>
            <a:lvl4pPr marL="1998345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4pPr>
            <a:lvl5pPr marL="2664460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5pPr>
            <a:lvl6pPr marL="3329940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6pPr>
            <a:lvl7pPr marL="3996055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7pPr>
            <a:lvl8pPr marL="4662170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8pPr>
            <a:lvl9pPr marL="5328285" indent="0">
              <a:buNone/>
              <a:defRPr sz="23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15799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743611" y="2875360"/>
            <a:ext cx="5661303" cy="68533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575074"/>
            <a:ext cx="11489115" cy="20877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7536" y="2647832"/>
            <a:ext cx="5635285" cy="1297661"/>
          </a:xfrm>
        </p:spPr>
        <p:txBody>
          <a:bodyPr anchor="b"/>
          <a:lstStyle>
            <a:lvl1pPr marL="0" indent="0">
              <a:buNone/>
              <a:defRPr sz="3495" b="1"/>
            </a:lvl1pPr>
            <a:lvl2pPr marL="666115" indent="0">
              <a:buNone/>
              <a:defRPr sz="2915" b="1"/>
            </a:lvl2pPr>
            <a:lvl3pPr marL="1332230" indent="0">
              <a:buNone/>
              <a:defRPr sz="2620" b="1"/>
            </a:lvl3pPr>
            <a:lvl4pPr marL="1998345" indent="0">
              <a:buNone/>
              <a:defRPr sz="2330" b="1"/>
            </a:lvl4pPr>
            <a:lvl5pPr marL="2664460" indent="0">
              <a:buNone/>
              <a:defRPr sz="2330" b="1"/>
            </a:lvl5pPr>
            <a:lvl6pPr marL="3329940" indent="0">
              <a:buNone/>
              <a:defRPr sz="2330" b="1"/>
            </a:lvl6pPr>
            <a:lvl7pPr marL="3996055" indent="0">
              <a:buNone/>
              <a:defRPr sz="2330" b="1"/>
            </a:lvl7pPr>
            <a:lvl8pPr marL="4662170" indent="0">
              <a:buNone/>
              <a:defRPr sz="2330" b="1"/>
            </a:lvl8pPr>
            <a:lvl9pPr marL="5328285" indent="0">
              <a:buNone/>
              <a:defRPr sz="233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7536" y="3945493"/>
            <a:ext cx="5635285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743612" y="2647832"/>
            <a:ext cx="5663038" cy="1297661"/>
          </a:xfrm>
        </p:spPr>
        <p:txBody>
          <a:bodyPr anchor="b"/>
          <a:lstStyle>
            <a:lvl1pPr marL="0" indent="0">
              <a:buNone/>
              <a:defRPr sz="3495" b="1"/>
            </a:lvl1pPr>
            <a:lvl2pPr marL="666115" indent="0">
              <a:buNone/>
              <a:defRPr sz="2915" b="1"/>
            </a:lvl2pPr>
            <a:lvl3pPr marL="1332230" indent="0">
              <a:buNone/>
              <a:defRPr sz="2620" b="1"/>
            </a:lvl3pPr>
            <a:lvl4pPr marL="1998345" indent="0">
              <a:buNone/>
              <a:defRPr sz="2330" b="1"/>
            </a:lvl4pPr>
            <a:lvl5pPr marL="2664460" indent="0">
              <a:buNone/>
              <a:defRPr sz="2330" b="1"/>
            </a:lvl5pPr>
            <a:lvl6pPr marL="3329940" indent="0">
              <a:buNone/>
              <a:defRPr sz="2330" b="1"/>
            </a:lvl6pPr>
            <a:lvl7pPr marL="3996055" indent="0">
              <a:buNone/>
              <a:defRPr sz="2330" b="1"/>
            </a:lvl7pPr>
            <a:lvl8pPr marL="4662170" indent="0">
              <a:buNone/>
              <a:defRPr sz="2330" b="1"/>
            </a:lvl8pPr>
            <a:lvl9pPr marL="5328285" indent="0">
              <a:buNone/>
              <a:defRPr sz="233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743612" y="3945493"/>
            <a:ext cx="5663038" cy="580322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63038" y="1555197"/>
            <a:ext cx="6743611" cy="7675959"/>
          </a:xfrm>
        </p:spPr>
        <p:txBody>
          <a:bodyPr/>
          <a:lstStyle>
            <a:lvl1pPr>
              <a:defRPr sz="4660"/>
            </a:lvl1pPr>
            <a:lvl2pPr>
              <a:defRPr sz="4080"/>
            </a:lvl2pPr>
            <a:lvl3pPr>
              <a:defRPr sz="3495"/>
            </a:lvl3pPr>
            <a:lvl4pPr>
              <a:defRPr sz="2915"/>
            </a:lvl4pPr>
            <a:lvl5pPr>
              <a:defRPr sz="2915"/>
            </a:lvl5pPr>
            <a:lvl6pPr>
              <a:defRPr sz="2915"/>
            </a:lvl6pPr>
            <a:lvl7pPr>
              <a:defRPr sz="2915"/>
            </a:lvl7pPr>
            <a:lvl8pPr>
              <a:defRPr sz="2915"/>
            </a:lvl8pPr>
            <a:lvl9pPr>
              <a:defRPr sz="291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0"/>
            </a:lvl1pPr>
            <a:lvl2pPr marL="666115" indent="0">
              <a:buNone/>
              <a:defRPr sz="2040"/>
            </a:lvl2pPr>
            <a:lvl3pPr marL="1332230" indent="0">
              <a:buNone/>
              <a:defRPr sz="1750"/>
            </a:lvl3pPr>
            <a:lvl4pPr marL="1998345" indent="0">
              <a:buNone/>
              <a:defRPr sz="1455"/>
            </a:lvl4pPr>
            <a:lvl5pPr marL="2664460" indent="0">
              <a:buNone/>
              <a:defRPr sz="1455"/>
            </a:lvl5pPr>
            <a:lvl6pPr marL="3329940" indent="0">
              <a:buNone/>
              <a:defRPr sz="1455"/>
            </a:lvl6pPr>
            <a:lvl7pPr marL="3996055" indent="0">
              <a:buNone/>
              <a:defRPr sz="1455"/>
            </a:lvl7pPr>
            <a:lvl8pPr marL="4662170" indent="0">
              <a:buNone/>
              <a:defRPr sz="1455"/>
            </a:lvl8pPr>
            <a:lvl9pPr marL="5328285" indent="0">
              <a:buNone/>
              <a:defRPr sz="14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7534" y="720090"/>
            <a:ext cx="4296277" cy="2520315"/>
          </a:xfrm>
        </p:spPr>
        <p:txBody>
          <a:bodyPr anchor="b"/>
          <a:lstStyle>
            <a:lvl1pPr>
              <a:defRPr sz="46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63038" y="1555197"/>
            <a:ext cx="6743611" cy="7675959"/>
          </a:xfrm>
        </p:spPr>
        <p:txBody>
          <a:bodyPr anchor="t"/>
          <a:lstStyle>
            <a:lvl1pPr marL="0" indent="0">
              <a:buNone/>
              <a:defRPr sz="4660"/>
            </a:lvl1pPr>
            <a:lvl2pPr marL="666115" indent="0">
              <a:buNone/>
              <a:defRPr sz="4080"/>
            </a:lvl2pPr>
            <a:lvl3pPr marL="1332230" indent="0">
              <a:buNone/>
              <a:defRPr sz="3495"/>
            </a:lvl3pPr>
            <a:lvl4pPr marL="1998345" indent="0">
              <a:buNone/>
              <a:defRPr sz="2915"/>
            </a:lvl4pPr>
            <a:lvl5pPr marL="2664460" indent="0">
              <a:buNone/>
              <a:defRPr sz="2915"/>
            </a:lvl5pPr>
            <a:lvl6pPr marL="3329940" indent="0">
              <a:buNone/>
              <a:defRPr sz="2915"/>
            </a:lvl6pPr>
            <a:lvl7pPr marL="3996055" indent="0">
              <a:buNone/>
              <a:defRPr sz="2915"/>
            </a:lvl7pPr>
            <a:lvl8pPr marL="4662170" indent="0">
              <a:buNone/>
              <a:defRPr sz="2915"/>
            </a:lvl8pPr>
            <a:lvl9pPr marL="5328285" indent="0">
              <a:buNone/>
              <a:defRPr sz="291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17534" y="3240405"/>
            <a:ext cx="4296277" cy="6003251"/>
          </a:xfrm>
        </p:spPr>
        <p:txBody>
          <a:bodyPr/>
          <a:lstStyle>
            <a:lvl1pPr marL="0" indent="0">
              <a:buNone/>
              <a:defRPr sz="2330"/>
            </a:lvl1pPr>
            <a:lvl2pPr marL="666115" indent="0">
              <a:buNone/>
              <a:defRPr sz="2040"/>
            </a:lvl2pPr>
            <a:lvl3pPr marL="1332230" indent="0">
              <a:buNone/>
              <a:defRPr sz="1750"/>
            </a:lvl3pPr>
            <a:lvl4pPr marL="1998345" indent="0">
              <a:buNone/>
              <a:defRPr sz="1455"/>
            </a:lvl4pPr>
            <a:lvl5pPr marL="2664460" indent="0">
              <a:buNone/>
              <a:defRPr sz="1455"/>
            </a:lvl5pPr>
            <a:lvl6pPr marL="3329940" indent="0">
              <a:buNone/>
              <a:defRPr sz="1455"/>
            </a:lvl6pPr>
            <a:lvl7pPr marL="3996055" indent="0">
              <a:buNone/>
              <a:defRPr sz="1455"/>
            </a:lvl7pPr>
            <a:lvl8pPr marL="4662170" indent="0">
              <a:buNone/>
              <a:defRPr sz="1455"/>
            </a:lvl8pPr>
            <a:lvl9pPr marL="5328285" indent="0">
              <a:buNone/>
              <a:defRPr sz="145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5799" y="575074"/>
            <a:ext cx="11489115" cy="2087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5799" y="2875360"/>
            <a:ext cx="11489115" cy="68533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15799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412486" y="10011254"/>
            <a:ext cx="449574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407754" y="10011254"/>
            <a:ext cx="299716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32230" rtl="0" eaLnBrk="1" latinLnBrk="0" hangingPunct="1">
        <a:lnSpc>
          <a:spcPct val="90000"/>
        </a:lnSpc>
        <a:spcBef>
          <a:spcPct val="0"/>
        </a:spcBef>
        <a:buNone/>
        <a:defRPr sz="641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2740" indent="-332740" algn="l" defTabSz="1332230" rtl="0" eaLnBrk="1" latinLnBrk="0" hangingPunct="1">
        <a:lnSpc>
          <a:spcPct val="90000"/>
        </a:lnSpc>
        <a:spcBef>
          <a:spcPts val="1455"/>
        </a:spcBef>
        <a:buFont typeface="Arial" panose="020B0604020202020204" pitchFamily="34" charset="0"/>
        <a:buChar char="•"/>
        <a:defRPr sz="4080" kern="1200">
          <a:solidFill>
            <a:schemeClr val="tx1"/>
          </a:solidFill>
          <a:latin typeface="+mn-lt"/>
          <a:ea typeface="+mn-ea"/>
          <a:cs typeface="+mn-cs"/>
        </a:defRPr>
      </a:lvl1pPr>
      <a:lvl2pPr marL="998855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3495" kern="1200">
          <a:solidFill>
            <a:schemeClr val="tx1"/>
          </a:solidFill>
          <a:latin typeface="+mn-lt"/>
          <a:ea typeface="+mn-ea"/>
          <a:cs typeface="+mn-cs"/>
        </a:defRPr>
      </a:lvl2pPr>
      <a:lvl3pPr marL="1664970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915" kern="1200">
          <a:solidFill>
            <a:schemeClr val="tx1"/>
          </a:solidFill>
          <a:latin typeface="+mn-lt"/>
          <a:ea typeface="+mn-ea"/>
          <a:cs typeface="+mn-cs"/>
        </a:defRPr>
      </a:lvl3pPr>
      <a:lvl4pPr marL="2331085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4pPr>
      <a:lvl5pPr marL="2997200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5pPr>
      <a:lvl6pPr marL="3663315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6pPr>
      <a:lvl7pPr marL="4329430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7pPr>
      <a:lvl8pPr marL="4995545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8pPr>
      <a:lvl9pPr marL="5661660" indent="-332740" algn="l" defTabSz="1332230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6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1pPr>
      <a:lvl2pPr marL="666115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2pPr>
      <a:lvl3pPr marL="1332230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3pPr>
      <a:lvl4pPr marL="1998345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4pPr>
      <a:lvl5pPr marL="2664460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5pPr>
      <a:lvl6pPr marL="3329940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6pPr>
      <a:lvl7pPr marL="3996055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7pPr>
      <a:lvl8pPr marL="4662170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8pPr>
      <a:lvl9pPr marL="5328285" algn="l" defTabSz="1332230" rtl="0" eaLnBrk="1" latinLnBrk="0" hangingPunct="1">
        <a:defRPr sz="26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microsoft.com/office/2007/relationships/hdphoto" Target="../media/hdphoto19.wdp"/><Relationship Id="rId3" Type="http://schemas.microsoft.com/office/2007/relationships/hdphoto" Target="../media/hdphoto1.wdp"/><Relationship Id="rId21" Type="http://schemas.microsoft.com/office/2007/relationships/hdphoto" Target="../media/hdphoto10.wdp"/><Relationship Id="rId34" Type="http://schemas.openxmlformats.org/officeDocument/2006/relationships/image" Target="../media/image17.png"/><Relationship Id="rId42" Type="http://schemas.openxmlformats.org/officeDocument/2006/relationships/image" Target="../media/image21.png"/><Relationship Id="rId47" Type="http://schemas.microsoft.com/office/2007/relationships/hdphoto" Target="../media/hdphoto23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3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microsoft.com/office/2007/relationships/hdphoto" Target="../media/hdphoto22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4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22.pn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24.png"/><Relationship Id="rId8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755993" y="1728267"/>
            <a:ext cx="130734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DIG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149T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60/136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783346" y="2113981"/>
            <a:ext cx="12799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DIG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898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4/72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14968" y="2736379"/>
            <a:ext cx="13483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NPB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G1362A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30/82 </a:t>
            </a:r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67668" y="3096419"/>
            <a:ext cx="15956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NPB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1554A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8/97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502956" y="4115098"/>
            <a:ext cx="15603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SN</a:t>
            </a:r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/CO</a:t>
            </a:r>
            <a:r>
              <a:rPr lang="en-US" altLang="zh-CN" sz="1100" baseline="300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2250G</a:t>
            </a:r>
            <a:endParaRPr lang="en-US" altLang="zh-CN" sz="1100" baseline="300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20/92 </a:t>
            </a:r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54113" y="749749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1217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07/73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54113" y="3672483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SN/CO</a:t>
            </a:r>
            <a:r>
              <a:rPr lang="en-US" altLang="zh-CN" sz="1100" baseline="300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T1841A</a:t>
            </a:r>
            <a:endParaRPr lang="en-US" altLang="zh-CN" sz="1100" baseline="300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95/161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54112" y="1136332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452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5/97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graphicFrame>
        <p:nvGraphicFramePr>
          <p:cNvPr id="23" name="表格 2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3575902"/>
              </p:ext>
            </p:extLst>
          </p:nvPr>
        </p:nvGraphicFramePr>
        <p:xfrm>
          <a:off x="2168742" y="47188"/>
          <a:ext cx="10338117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15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20055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200558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200558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89179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39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1"/>
                    </a:ext>
                  </a:extLst>
                </a:gridCol>
                <a:gridCol w="192970">
                  <a:extLst>
                    <a:ext uri="{9D8B030D-6E8A-4147-A177-3AD203B41FA5}">
                      <a16:colId xmlns:a16="http://schemas.microsoft.com/office/drawing/2014/main" xmlns="" val="20042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3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4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5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6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7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8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49"/>
                    </a:ext>
                  </a:extLst>
                </a:gridCol>
                <a:gridCol w="200558">
                  <a:extLst>
                    <a:ext uri="{9D8B030D-6E8A-4147-A177-3AD203B41FA5}">
                      <a16:colId xmlns:a16="http://schemas.microsoft.com/office/drawing/2014/main" xmlns="" val="20050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51"/>
                    </a:ext>
                  </a:extLst>
                </a:gridCol>
                <a:gridCol w="195154">
                  <a:extLst>
                    <a:ext uri="{9D8B030D-6E8A-4147-A177-3AD203B41FA5}">
                      <a16:colId xmlns:a16="http://schemas.microsoft.com/office/drawing/2014/main" xmlns="" val="20052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kern="1200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kern="1200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1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K6</a:t>
                      </a:r>
                      <a:endParaRPr lang="en-US" sz="1200" b="1" i="0" u="none" strike="noStrike" kern="1200" dirty="0">
                        <a:solidFill>
                          <a:srgbClr val="FF33CC"/>
                        </a:solidFill>
                        <a:effectLst/>
                        <a:latin typeface="Palatino Linotype" panose="02040502050505030304" pitchFamily="18" charset="0"/>
                        <a:ea typeface="+mn-ea"/>
                        <a:cs typeface="Times New Roman" panose="02020603050405020304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6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133223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7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7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8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6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7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8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99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0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sng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rgbClr val="3333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pic>
        <p:nvPicPr>
          <p:cNvPr id="27" name="图片 26"/>
          <p:cNvPicPr/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6000" contrast="-32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7993" r="4293"/>
          <a:stretch>
            <a:fillRect/>
          </a:stretch>
        </p:blipFill>
        <p:spPr>
          <a:xfrm>
            <a:off x="2178138" y="1745710"/>
            <a:ext cx="5245200" cy="360000"/>
          </a:xfrm>
          <a:prstGeom prst="rect">
            <a:avLst/>
          </a:prstGeom>
        </p:spPr>
      </p:pic>
      <p:pic>
        <p:nvPicPr>
          <p:cNvPr id="29" name="图片 28"/>
          <p:cNvPicPr/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8000" contrast="-32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655" b="8406"/>
          <a:stretch>
            <a:fillRect/>
          </a:stretch>
        </p:blipFill>
        <p:spPr>
          <a:xfrm>
            <a:off x="7466859" y="1745710"/>
            <a:ext cx="5040000" cy="360000"/>
          </a:xfrm>
          <a:prstGeom prst="rect">
            <a:avLst/>
          </a:prstGeom>
        </p:spPr>
      </p:pic>
      <p:pic>
        <p:nvPicPr>
          <p:cNvPr id="31" name="图片 30"/>
          <p:cNvPicPr/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6000" contrast="-28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999" r="3578" b="77"/>
          <a:stretch>
            <a:fillRect/>
          </a:stretch>
        </p:blipFill>
        <p:spPr>
          <a:xfrm>
            <a:off x="2178138" y="767192"/>
            <a:ext cx="5245200" cy="360000"/>
          </a:xfrm>
          <a:prstGeom prst="rect">
            <a:avLst/>
          </a:prstGeom>
        </p:spPr>
      </p:pic>
      <p:pic>
        <p:nvPicPr>
          <p:cNvPr id="33" name="图片 32"/>
          <p:cNvPicPr/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15000" contrast="-20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715" r="46"/>
          <a:stretch>
            <a:fillRect/>
          </a:stretch>
        </p:blipFill>
        <p:spPr>
          <a:xfrm>
            <a:off x="7466859" y="767192"/>
            <a:ext cx="5040000" cy="360000"/>
          </a:xfrm>
          <a:prstGeom prst="rect">
            <a:avLst/>
          </a:prstGeom>
        </p:spPr>
      </p:pic>
      <p:pic>
        <p:nvPicPr>
          <p:cNvPr id="35" name="图片 34"/>
          <p:cNvPicPr/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12000" contrast="-31000"/>
                    </a14:imgEffect>
                    <a14:imgEffect>
                      <a14:sharpenSoften amount="65000"/>
                    </a14:imgEffect>
                  </a14:imgLayer>
                </a14:imgProps>
              </a:ext>
            </a:extLst>
          </a:blip>
          <a:srcRect t="3924" r="3142"/>
          <a:stretch>
            <a:fillRect/>
          </a:stretch>
        </p:blipFill>
        <p:spPr>
          <a:xfrm>
            <a:off x="2178137" y="1153775"/>
            <a:ext cx="5245200" cy="360000"/>
          </a:xfrm>
          <a:prstGeom prst="rect">
            <a:avLst/>
          </a:prstGeom>
        </p:spPr>
      </p:pic>
      <p:pic>
        <p:nvPicPr>
          <p:cNvPr id="39" name="图片 38"/>
          <p:cNvPicPr/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-27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687" t="1" b="4228"/>
          <a:stretch>
            <a:fillRect/>
          </a:stretch>
        </p:blipFill>
        <p:spPr>
          <a:xfrm>
            <a:off x="7466859" y="1153775"/>
            <a:ext cx="5040000" cy="360000"/>
          </a:xfrm>
          <a:prstGeom prst="rect">
            <a:avLst/>
          </a:prstGeom>
        </p:spPr>
      </p:pic>
      <p:pic>
        <p:nvPicPr>
          <p:cNvPr id="20" name="图片 19"/>
          <p:cNvPicPr/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-33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11741" r="3663"/>
          <a:stretch>
            <a:fillRect/>
          </a:stretch>
        </p:blipFill>
        <p:spPr>
          <a:xfrm>
            <a:off x="2178138" y="4145578"/>
            <a:ext cx="5245200" cy="360000"/>
          </a:xfrm>
          <a:prstGeom prst="rect">
            <a:avLst/>
          </a:prstGeom>
        </p:spPr>
      </p:pic>
      <p:pic>
        <p:nvPicPr>
          <p:cNvPr id="24" name="图片 23"/>
          <p:cNvPicPr/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-28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495" t="12398" b="4948"/>
          <a:stretch>
            <a:fillRect/>
          </a:stretch>
        </p:blipFill>
        <p:spPr>
          <a:xfrm>
            <a:off x="7466859" y="4145578"/>
            <a:ext cx="5040000" cy="360000"/>
          </a:xfrm>
          <a:prstGeom prst="rect">
            <a:avLst/>
          </a:prstGeom>
        </p:spPr>
      </p:pic>
      <p:pic>
        <p:nvPicPr>
          <p:cNvPr id="38" name="图片 37"/>
          <p:cNvPicPr/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10000" contrast="-32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3968"/>
          <a:stretch>
            <a:fillRect/>
          </a:stretch>
        </p:blipFill>
        <p:spPr>
          <a:xfrm>
            <a:off x="7466859" y="3761934"/>
            <a:ext cx="5040000" cy="360000"/>
          </a:xfrm>
          <a:prstGeom prst="rect">
            <a:avLst/>
          </a:prstGeom>
        </p:spPr>
      </p:pic>
      <p:pic>
        <p:nvPicPr>
          <p:cNvPr id="42" name="图片 41"/>
          <p:cNvPicPr/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8000" contrast="-32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t="2986" r="3525"/>
          <a:stretch>
            <a:fillRect/>
          </a:stretch>
        </p:blipFill>
        <p:spPr>
          <a:xfrm>
            <a:off x="2178138" y="3761934"/>
            <a:ext cx="5245200" cy="360000"/>
          </a:xfrm>
          <a:prstGeom prst="rect">
            <a:avLst/>
          </a:prstGeom>
        </p:spPr>
      </p:pic>
      <p:pic>
        <p:nvPicPr>
          <p:cNvPr id="10" name="图片 9"/>
          <p:cNvPicPr/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-34000"/>
                    </a14:imgEffect>
                    <a14:imgEffect>
                      <a14:sharpenSoften amount="77000"/>
                    </a14:imgEffect>
                  </a14:imgLayer>
                </a14:imgProps>
              </a:ext>
            </a:extLst>
          </a:blip>
          <a:srcRect t="8901" r="3722" b="1414"/>
          <a:stretch>
            <a:fillRect/>
          </a:stretch>
        </p:blipFill>
        <p:spPr>
          <a:xfrm>
            <a:off x="2178138" y="3159052"/>
            <a:ext cx="5245200" cy="360000"/>
          </a:xfrm>
          <a:prstGeom prst="rect">
            <a:avLst/>
          </a:prstGeom>
        </p:spPr>
      </p:pic>
      <p:pic>
        <p:nvPicPr>
          <p:cNvPr id="16" name="图片 15"/>
          <p:cNvPicPr/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contrast="-25000"/>
                    </a14:imgEffect>
                    <a14:imgEffect>
                      <a14:sharpenSoften amount="70000"/>
                    </a14:imgEffect>
                  </a14:imgLayer>
                </a14:imgProps>
              </a:ext>
            </a:extLst>
          </a:blip>
          <a:srcRect l="4031" t="12054" b="39"/>
          <a:stretch>
            <a:fillRect/>
          </a:stretch>
        </p:blipFill>
        <p:spPr>
          <a:xfrm>
            <a:off x="7466859" y="3159052"/>
            <a:ext cx="5040000" cy="360000"/>
          </a:xfrm>
          <a:prstGeom prst="rect">
            <a:avLst/>
          </a:prstGeom>
        </p:spPr>
      </p:pic>
      <p:pic>
        <p:nvPicPr>
          <p:cNvPr id="11" name="图片 10"/>
          <p:cNvPicPr/>
          <p:nvPr/>
        </p:nvPicPr>
        <p:blipFill rotWithShape="1"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sharpenSoften amount="59000"/>
                    </a14:imgEffect>
                  </a14:imgLayer>
                </a14:imgProps>
              </a:ext>
            </a:extLst>
          </a:blip>
          <a:srcRect t="8977"/>
          <a:stretch>
            <a:fillRect/>
          </a:stretch>
        </p:blipFill>
        <p:spPr>
          <a:xfrm>
            <a:off x="2178138" y="2760401"/>
            <a:ext cx="5245200" cy="360000"/>
          </a:xfrm>
          <a:prstGeom prst="rect">
            <a:avLst/>
          </a:prstGeom>
        </p:spPr>
      </p:pic>
      <p:pic>
        <p:nvPicPr>
          <p:cNvPr id="15" name="图片 14"/>
          <p:cNvPicPr/>
          <p:nvPr/>
        </p:nvPicPr>
        <p:blipFill rotWithShape="1"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contrast="-3000"/>
                    </a14:imgEffect>
                    <a14:imgEffect>
                      <a14:sharpenSoften amount="67000"/>
                    </a14:imgEffect>
                  </a14:imgLayer>
                </a14:imgProps>
              </a:ext>
            </a:extLst>
          </a:blip>
          <a:srcRect t="5680" b="766"/>
          <a:stretch>
            <a:fillRect/>
          </a:stretch>
        </p:blipFill>
        <p:spPr>
          <a:xfrm>
            <a:off x="7466859" y="2760398"/>
            <a:ext cx="5040000" cy="360000"/>
          </a:xfrm>
          <a:prstGeom prst="rect">
            <a:avLst/>
          </a:prstGeom>
        </p:spPr>
      </p:pic>
      <p:pic>
        <p:nvPicPr>
          <p:cNvPr id="12" name="图片 11"/>
          <p:cNvPicPr/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26000" contrast="-17000"/>
                    </a14:imgEffect>
                    <a14:imgEffect>
                      <a14:sharpenSoften amount="5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78138" y="2151225"/>
            <a:ext cx="5245200" cy="360000"/>
          </a:xfrm>
          <a:prstGeom prst="rect">
            <a:avLst/>
          </a:prstGeom>
        </p:spPr>
      </p:pic>
      <p:pic>
        <p:nvPicPr>
          <p:cNvPr id="18" name="图片 17"/>
          <p:cNvPicPr/>
          <p:nvPr/>
        </p:nvPicPr>
        <p:blipFill rotWithShape="1"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-12000" contrast="-28000"/>
                    </a14:imgEffect>
                    <a14:imgEffect>
                      <a14:sharpenSoften amount="43000"/>
                    </a14:imgEffect>
                  </a14:imgLayer>
                </a14:imgProps>
              </a:ext>
            </a:extLst>
          </a:blip>
          <a:srcRect t="9102" b="1574"/>
          <a:stretch>
            <a:fillRect/>
          </a:stretch>
        </p:blipFill>
        <p:spPr>
          <a:xfrm>
            <a:off x="7466859" y="2151225"/>
            <a:ext cx="5040000" cy="360000"/>
          </a:xfrm>
          <a:prstGeom prst="rect">
            <a:avLst/>
          </a:prstGeom>
        </p:spPr>
      </p:pic>
      <p:sp>
        <p:nvSpPr>
          <p:cNvPr id="32" name="TextBox 6"/>
          <p:cNvSpPr txBox="1"/>
          <p:nvPr/>
        </p:nvSpPr>
        <p:spPr>
          <a:xfrm>
            <a:off x="313879" y="576139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A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34" name="TextBox 6"/>
          <p:cNvSpPr txBox="1"/>
          <p:nvPr/>
        </p:nvSpPr>
        <p:spPr>
          <a:xfrm>
            <a:off x="313879" y="1512243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B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36" name="TextBox 6"/>
          <p:cNvSpPr txBox="1"/>
          <p:nvPr/>
        </p:nvSpPr>
        <p:spPr>
          <a:xfrm>
            <a:off x="313879" y="2500610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C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37" name="TextBox 6"/>
          <p:cNvSpPr txBox="1"/>
          <p:nvPr/>
        </p:nvSpPr>
        <p:spPr>
          <a:xfrm>
            <a:off x="313879" y="3456459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D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765766" y="6492523"/>
            <a:ext cx="130734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DIG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149T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60/136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793119" y="6878237"/>
            <a:ext cx="12799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DIG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898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4/72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724741" y="7500635"/>
            <a:ext cx="13483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NPB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G1362A</a:t>
            </a: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30/82 </a:t>
            </a:r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477441" y="7842027"/>
            <a:ext cx="159566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NPB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1554A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8/97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512729" y="8873078"/>
            <a:ext cx="15603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SN</a:t>
            </a:r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/CO</a:t>
            </a:r>
            <a:r>
              <a:rPr lang="en-US" altLang="zh-CN" sz="1100" baseline="300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2250G</a:t>
            </a:r>
            <a:endParaRPr lang="en-US" altLang="zh-CN" sz="1100" baseline="300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20/92 </a:t>
            </a:r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663886" y="5514005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C1217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07/73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663885" y="5900588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F/N</a:t>
            </a:r>
            <a:r>
              <a:rPr lang="en-US" altLang="zh-CN" sz="1100" baseline="300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A1452G</a:t>
            </a: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15/97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sp>
        <p:nvSpPr>
          <p:cNvPr id="51" name="TextBox 6"/>
          <p:cNvSpPr txBox="1"/>
          <p:nvPr/>
        </p:nvSpPr>
        <p:spPr>
          <a:xfrm>
            <a:off x="323652" y="5340395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E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52" name="TextBox 6"/>
          <p:cNvSpPr txBox="1"/>
          <p:nvPr/>
        </p:nvSpPr>
        <p:spPr>
          <a:xfrm>
            <a:off x="323652" y="6276499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F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53" name="TextBox 6"/>
          <p:cNvSpPr txBox="1"/>
          <p:nvPr/>
        </p:nvSpPr>
        <p:spPr>
          <a:xfrm>
            <a:off x="323652" y="7264866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G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54" name="TextBox 6"/>
          <p:cNvSpPr txBox="1"/>
          <p:nvPr/>
        </p:nvSpPr>
        <p:spPr>
          <a:xfrm>
            <a:off x="323652" y="8220715"/>
            <a:ext cx="3735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Palatino Linotype" panose="02040502050505030304" pitchFamily="18" charset="0"/>
                <a:cs typeface="Times New Roman" panose="02020603050405020304" charset="0"/>
              </a:rPr>
              <a:t>H</a:t>
            </a:r>
            <a:endParaRPr lang="zh-CN" altLang="en-US" sz="1400" b="1" dirty="0">
              <a:latin typeface="Palatino Linotype" panose="02040502050505030304" pitchFamily="18" charset="0"/>
              <a:cs typeface="Times New Roman" panose="0202060305040502030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54113" y="9442295"/>
            <a:ext cx="120027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smtClean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charset="0"/>
              </a:rPr>
              <a:t>Figure </a:t>
            </a:r>
            <a:r>
              <a:rPr lang="en-US" altLang="zh-CN" sz="1200" b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charset="0"/>
              </a:rPr>
              <a:t>S6. 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lele mining of the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id4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alleles in the additional </a:t>
            </a:r>
            <a:r>
              <a:rPr lang="en-US" altLang="zh-CN" sz="1200" i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Xian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A to D) and </a:t>
            </a:r>
            <a:r>
              <a:rPr lang="en-US" altLang="zh-CN" sz="1200" i="1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Geng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(E</a:t>
            </a:r>
            <a:r>
              <a:rPr lang="zh-CN" altLang="en-US" sz="1200" b="1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o H) rice cultivar panels, in the former four </a:t>
            </a:r>
            <a:r>
              <a:rPr lang="en-US" altLang="zh-CN" sz="1200" kern="100" dirty="0" err="1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s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which were repeated from the regular panel, were ruled out</a:t>
            </a:r>
            <a:r>
              <a:rPr lang="en-US" altLang="zh-CN" sz="1200" kern="100" dirty="0"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charset="0"/>
              </a:rPr>
              <a:t>. 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CK1, Digu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-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DIG; red); CK2, Tetep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-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Null; black); CK3, </a:t>
            </a:r>
            <a:r>
              <a:rPr lang="en-US" altLang="zh-CN" sz="1200" kern="100" dirty="0" err="1">
                <a:latin typeface="Palatino Linotype" panose="02040502050505030304" pitchFamily="18" charset="0"/>
              </a:rPr>
              <a:t>Zhenshan</a:t>
            </a:r>
            <a:r>
              <a:rPr lang="en-US" altLang="zh-CN" sz="1200" kern="100" dirty="0">
                <a:latin typeface="Palatino Linotype" panose="02040502050505030304" pitchFamily="18" charset="0"/>
              </a:rPr>
              <a:t> 97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-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Null; black); CK4, Nipponbare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-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NPB; blue); CK5, </a:t>
            </a:r>
            <a:r>
              <a:rPr lang="en-US" altLang="zh-CN" sz="1200" kern="100" dirty="0" err="1">
                <a:solidFill>
                  <a:srgbClr val="000000"/>
                </a:solidFill>
                <a:latin typeface="Palatino Linotype" panose="02040502050505030304" pitchFamily="18" charset="0"/>
              </a:rPr>
              <a:t>Shennong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 265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-SN; green); CK6, CO39 (</a:t>
            </a:r>
            <a:r>
              <a:rPr lang="en-US" altLang="zh-CN" sz="1200" i="1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Pid4-</a:t>
            </a:r>
            <a:r>
              <a:rPr lang="en-US" altLang="zh-CN" sz="1200" kern="100" dirty="0">
                <a:solidFill>
                  <a:srgbClr val="000000"/>
                </a:solidFill>
                <a:latin typeface="Palatino Linotype" panose="02040502050505030304" pitchFamily="18" charset="0"/>
              </a:rPr>
              <a:t>CO; rose-red); and undefined allele carried by CVs 63, 87, 102, 104, 106, and 126, was marked in purple. M: DL-500 size marker.</a:t>
            </a:r>
          </a:p>
        </p:txBody>
      </p:sp>
      <p:graphicFrame>
        <p:nvGraphicFramePr>
          <p:cNvPr id="55" name="表格 5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0033945"/>
              </p:ext>
            </p:extLst>
          </p:nvPr>
        </p:nvGraphicFramePr>
        <p:xfrm>
          <a:off x="2168742" y="4799716"/>
          <a:ext cx="7288301" cy="67296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7547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195336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191500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  <a:gridCol w="191500">
                  <a:extLst>
                    <a:ext uri="{9D8B030D-6E8A-4147-A177-3AD203B41FA5}">
                      <a16:colId xmlns:a16="http://schemas.microsoft.com/office/drawing/2014/main" xmlns="" val="20012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3"/>
                    </a:ext>
                  </a:extLst>
                </a:gridCol>
                <a:gridCol w="195336">
                  <a:extLst>
                    <a:ext uri="{9D8B030D-6E8A-4147-A177-3AD203B41FA5}">
                      <a16:colId xmlns:a16="http://schemas.microsoft.com/office/drawing/2014/main" xmlns="" val="20014"/>
                    </a:ext>
                  </a:extLst>
                </a:gridCol>
                <a:gridCol w="195336">
                  <a:extLst>
                    <a:ext uri="{9D8B030D-6E8A-4147-A177-3AD203B41FA5}">
                      <a16:colId xmlns:a16="http://schemas.microsoft.com/office/drawing/2014/main" xmlns="" val="20015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6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7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8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19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0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1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2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3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4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5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6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7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8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29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0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1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2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3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4"/>
                    </a:ext>
                  </a:extLst>
                </a:gridCol>
                <a:gridCol w="195336">
                  <a:extLst>
                    <a:ext uri="{9D8B030D-6E8A-4147-A177-3AD203B41FA5}">
                      <a16:colId xmlns:a16="http://schemas.microsoft.com/office/drawing/2014/main" xmlns="" val="20035"/>
                    </a:ext>
                  </a:extLst>
                </a:gridCol>
                <a:gridCol w="197547">
                  <a:extLst>
                    <a:ext uri="{9D8B030D-6E8A-4147-A177-3AD203B41FA5}">
                      <a16:colId xmlns:a16="http://schemas.microsoft.com/office/drawing/2014/main" xmlns="" val="20036"/>
                    </a:ext>
                  </a:extLst>
                </a:gridCol>
              </a:tblGrid>
              <a:tr h="67296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FF000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1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2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3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5</a:t>
                      </a: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1" i="0" u="none" strike="noStrike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6</a:t>
                      </a:r>
                      <a:endParaRPr lang="en-US" sz="1200" b="1" i="0" u="none" strike="noStrike" dirty="0">
                        <a:solidFill>
                          <a:srgbClr val="FF33CC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charset="0"/>
                      </a:endParaRPr>
                    </a:p>
                  </a:txBody>
                  <a:tcPr marL="8839" marR="8839" marT="15461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0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1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1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1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1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1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2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2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3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5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7030A0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6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27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28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5427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29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1332230" rtl="0" eaLnBrk="1" fontAlgn="b" latinLnBrk="0" hangingPunct="1"/>
                      <a:r>
                        <a:rPr lang="en-US" altLang="zh-CN" sz="1200" b="0" i="0" u="none" strike="noStrike" kern="1200" dirty="0">
                          <a:solidFill>
                            <a:srgbClr val="FF33CC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  <a:cs typeface="Times New Roman" panose="02020603050405020304" charset="0"/>
                        </a:rPr>
                        <a:t>CV130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1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V132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FF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CK4</a:t>
                      </a:r>
                    </a:p>
                  </a:txBody>
                  <a:tcPr marL="8063" marR="8063" marT="14153" marB="0" vert="vert27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charset="0"/>
                        </a:rPr>
                        <a:t>M</a:t>
                      </a:r>
                    </a:p>
                  </a:txBody>
                  <a:tcPr marL="8839" marR="8839" marT="15461" marB="0" vert="vert27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</a:tbl>
          </a:graphicData>
        </a:graphic>
      </p:graphicFrame>
      <p:pic>
        <p:nvPicPr>
          <p:cNvPr id="14" name="图片 13"/>
          <p:cNvPicPr preferRelativeResize="0"/>
          <p:nvPr/>
        </p:nvPicPr>
        <p:blipFill rotWithShape="1"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446" t="7222" r="670" b="20193"/>
          <a:stretch>
            <a:fillRect/>
          </a:stretch>
        </p:blipFill>
        <p:spPr>
          <a:xfrm>
            <a:off x="2194999" y="5957641"/>
            <a:ext cx="7261200" cy="360000"/>
          </a:xfrm>
          <a:prstGeom prst="rect">
            <a:avLst/>
          </a:prstGeom>
        </p:spPr>
      </p:pic>
      <p:pic>
        <p:nvPicPr>
          <p:cNvPr id="6" name="图片 5"/>
          <p:cNvPicPr preferRelativeResize="0"/>
          <p:nvPr/>
        </p:nvPicPr>
        <p:blipFill rotWithShape="1"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722" t="26446" r="810" b="6030"/>
          <a:stretch>
            <a:fillRect/>
          </a:stretch>
        </p:blipFill>
        <p:spPr>
          <a:xfrm>
            <a:off x="2194999" y="6550363"/>
            <a:ext cx="7261200" cy="360000"/>
          </a:xfrm>
          <a:prstGeom prst="rect">
            <a:avLst/>
          </a:prstGeom>
        </p:spPr>
      </p:pic>
      <p:pic>
        <p:nvPicPr>
          <p:cNvPr id="8" name="图片 7"/>
          <p:cNvPicPr preferRelativeResize="0"/>
          <p:nvPr/>
        </p:nvPicPr>
        <p:blipFill rotWithShape="1"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rcRect l="766" r="739"/>
          <a:stretch>
            <a:fillRect/>
          </a:stretch>
        </p:blipFill>
        <p:spPr>
          <a:xfrm>
            <a:off x="2194999" y="6955666"/>
            <a:ext cx="7261200" cy="360000"/>
          </a:xfrm>
          <a:prstGeom prst="rect">
            <a:avLst/>
          </a:prstGeom>
        </p:spPr>
      </p:pic>
      <p:pic>
        <p:nvPicPr>
          <p:cNvPr id="22" name="图片 21"/>
          <p:cNvPicPr preferRelativeResize="0"/>
          <p:nvPr/>
        </p:nvPicPr>
        <p:blipFill>
          <a:blip r:embed="rId40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94999" y="8895579"/>
            <a:ext cx="7261200" cy="360000"/>
          </a:xfrm>
          <a:prstGeom prst="rect">
            <a:avLst/>
          </a:prstGeom>
        </p:spPr>
      </p:pic>
      <p:pic>
        <p:nvPicPr>
          <p:cNvPr id="26" name="图片 25"/>
          <p:cNvPicPr preferRelativeResize="0"/>
          <p:nvPr/>
        </p:nvPicPr>
        <p:blipFill>
          <a:blip r:embed="rId42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194999" y="8497059"/>
            <a:ext cx="7261200" cy="360000"/>
          </a:xfrm>
          <a:prstGeom prst="rect">
            <a:avLst/>
          </a:prstGeom>
        </p:spPr>
      </p:pic>
      <p:pic>
        <p:nvPicPr>
          <p:cNvPr id="40" name="图片 39"/>
          <p:cNvPicPr preferRelativeResize="0"/>
          <p:nvPr/>
        </p:nvPicPr>
        <p:blipFill rotWithShape="1">
          <a:blip r:embed="rId44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20000" contrast="-40000"/>
                    </a14:imgEffect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l="760" r="868"/>
          <a:stretch>
            <a:fillRect/>
          </a:stretch>
        </p:blipFill>
        <p:spPr>
          <a:xfrm>
            <a:off x="2194999" y="7911470"/>
            <a:ext cx="7261200" cy="360000"/>
          </a:xfrm>
          <a:prstGeom prst="rect">
            <a:avLst/>
          </a:prstGeom>
        </p:spPr>
      </p:pic>
      <p:sp>
        <p:nvSpPr>
          <p:cNvPr id="64" name="文本框 63"/>
          <p:cNvSpPr txBox="1"/>
          <p:nvPr/>
        </p:nvSpPr>
        <p:spPr>
          <a:xfrm>
            <a:off x="697175" y="8425011"/>
            <a:ext cx="140922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Pid4-SN/CO</a:t>
            </a:r>
            <a:r>
              <a:rPr lang="en-US" altLang="zh-CN" sz="1100" baseline="3000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T1841A</a:t>
            </a:r>
            <a:endParaRPr lang="en-US" altLang="zh-CN" sz="1100" baseline="300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  <a:p>
            <a:pPr algn="r"/>
            <a:r>
              <a:rPr lang="en-US" altLang="zh-CN" sz="1100" dirty="0">
                <a:latin typeface="Palatino Linotype" panose="02040502050505030304" pitchFamily="18" charset="0"/>
                <a:ea typeface="华文楷体" panose="02010600040101010101" pitchFamily="2" charset="-122"/>
                <a:cs typeface="Times New Roman" panose="02020603050405020304" charset="0"/>
              </a:rPr>
              <a:t>(195/161 bp)</a:t>
            </a:r>
            <a:endParaRPr lang="zh-CN" altLang="en-US" sz="1100" dirty="0">
              <a:latin typeface="Palatino Linotype" panose="02040502050505030304" pitchFamily="18" charset="0"/>
              <a:ea typeface="华文楷体" panose="02010600040101010101" pitchFamily="2" charset="-122"/>
              <a:cs typeface="Times New Roman" panose="02020603050405020304" charset="0"/>
            </a:endParaRPr>
          </a:p>
        </p:txBody>
      </p:sp>
      <p:pic>
        <p:nvPicPr>
          <p:cNvPr id="66" name="图片 65"/>
          <p:cNvPicPr preferRelativeResize="0"/>
          <p:nvPr/>
        </p:nvPicPr>
        <p:blipFill rotWithShape="1">
          <a:blip r:embed="rId46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349"/>
          <a:stretch>
            <a:fillRect/>
          </a:stretch>
        </p:blipFill>
        <p:spPr>
          <a:xfrm>
            <a:off x="2192455" y="7506167"/>
            <a:ext cx="7261200" cy="360000"/>
          </a:xfrm>
          <a:prstGeom prst="rect">
            <a:avLst/>
          </a:prstGeom>
        </p:spPr>
      </p:pic>
      <p:pic>
        <p:nvPicPr>
          <p:cNvPr id="56" name="图片 55"/>
          <p:cNvPicPr preferRelativeResize="0"/>
          <p:nvPr/>
        </p:nvPicPr>
        <p:blipFill rotWithShape="1"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22000" contrast="-21000"/>
                    </a14:imgEffect>
                    <a14:imgEffect>
                      <a14:sharpenSoften amount="23000"/>
                    </a14:imgEffect>
                  </a14:imgLayer>
                </a14:imgProps>
              </a:ext>
            </a:extLst>
          </a:blip>
          <a:srcRect l="587" r="1"/>
          <a:stretch>
            <a:fillRect/>
          </a:stretch>
        </p:blipFill>
        <p:spPr>
          <a:xfrm>
            <a:off x="2194999" y="5555324"/>
            <a:ext cx="7261200" cy="3600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96</TotalTime>
  <Words>305</Words>
  <Application>Microsoft Office PowerPoint</Application>
  <PresentationFormat>Custom</PresentationFormat>
  <Paragraphs>1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9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1" baseType="lpstr">
      <vt:lpstr>等线</vt:lpstr>
      <vt:lpstr>等线 Light</vt:lpstr>
      <vt:lpstr>华文楷体</vt:lpstr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公共</dc:creator>
  <cp:lastModifiedBy>MDPI</cp:lastModifiedBy>
  <cp:revision>2289</cp:revision>
  <cp:lastPrinted>2021-02-15T13:52:57Z</cp:lastPrinted>
  <dcterms:created xsi:type="dcterms:W3CDTF">2018-08-28T01:53:00Z</dcterms:created>
  <dcterms:modified xsi:type="dcterms:W3CDTF">2022-05-17T08:07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9228</vt:lpwstr>
  </property>
</Properties>
</file>